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3"/>
  </p:normalViewPr>
  <p:slideViewPr>
    <p:cSldViewPr snapToGrid="0">
      <p:cViewPr varScale="1">
        <p:scale>
          <a:sx n="100" d="100"/>
          <a:sy n="100" d="100"/>
        </p:scale>
        <p:origin x="10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35D33D-4A35-28BD-1934-EAB9231C8F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5E55AC0-8C6B-E8EE-73D5-F387B844B6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5F9EEA-5802-F31B-1EE4-DEA621246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1E30CA-BF6C-8D2F-6EBB-64176014B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1DE73-FF86-9343-2704-0B6A9F7F1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114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BAB2ED-2822-79E1-F455-4390BF08F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E496CA-9EF9-3399-5F2F-6DF809D498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3AE89-89BB-FDBC-C2F8-77DBAB0CB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D50253-78C3-DA2C-9104-F687C3338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D5D776-53E4-33E3-5245-B2DF54D4B6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385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514C881-3502-7952-28E9-D9B632C762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24DE25-0066-D4D4-76CC-E70EF827E7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FDCB10-E280-C05F-0B36-2696BF008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CDFB7F-A93B-5DE4-862A-D0769E13C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D1DAC-4754-F124-29A6-456FFF5F1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432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6B738E-D288-3281-C909-B3596D1959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F2E490-4A87-D077-23B1-66AE6E0381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624C37-A9AE-42ED-111D-17FC744C8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66349-FB2F-904E-481F-06389EE53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7F4EB3-843D-2828-EC88-CB8B1CB15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9822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596B1-2620-5BDF-40D8-C3600921DB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0628EF-8D97-A6FD-7E4E-27CECA905A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89A1C2-6ABB-B86C-8D66-64E855965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D40E29-7383-3895-0CAE-A10703569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108802-5C20-9B20-7CA8-2C46F7737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6123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85DE5-4FEF-F180-2B1C-6BEC5C719F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622ED5-5BFE-7C46-9C77-9565C3CACE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4BC4B9-768C-F8BA-622A-A788341E84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1DCFC2-6825-F562-61C9-569D302EC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0C1101-DF4F-3B51-C74A-14FCE48823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9E5186-EDB7-843D-283A-7CF9DC69A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206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26A694-4C9E-AB51-73E8-A4B9D78E79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04A476-FDDE-0550-0FDF-7211EBB660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538485-374B-1694-06CD-4ACCB15D7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57E331F-5A7B-6B61-FE06-61D20B0861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DE733B-E251-9700-7931-75906DC2FD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FEFDA6-B7D1-DE17-F886-0EEE5DE65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DB881B-5ED9-6572-C201-FF09A2AC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25BBDB-8D17-A60D-F007-2EEE198A2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344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D644C-6261-C3EB-B095-4E69A3AEDB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AB02B2-C2BC-E662-4174-C6D8486F22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8EEB1B-318B-8D71-2E98-7C6EF5229E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97DC15-089E-ECA4-7F84-153E04CA9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2989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F8EC99E-D92F-5C7C-B893-7639EBAFF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D002E4-AD95-6F8D-D6E3-61B8083B4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7801F8-1488-9C6E-0C91-DF5CB094CE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9942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868A3-4AA3-40B9-BB4A-4EBBF088F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67FE50-6643-BD0C-D9EB-8322E33277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353EF3-1C16-252C-D48B-D99CDBB98D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0B4B33-8109-C02D-D301-7C42BB758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932A08-E59F-CE4D-09D5-1C404F31A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CB2448-6246-A06B-FEDB-ED2113A90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72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E02666-E193-E6FB-E669-9000FBC0B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6D0DD5-74F0-9FB0-839E-C99D87DB6D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AA4DDA-02B8-BB3A-64B4-A26028D234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9797FF-C917-A3A4-87B7-2FFEF0417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55BAFF-D8D6-9243-6DBD-F015D7843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A875EC-14CC-7D74-DAF1-617DE745B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7545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565DB5-610C-C1DB-6D85-B9774D332D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FCA4CA-9734-EE32-7A53-3C33B77AEC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88D92D-5652-03A6-F21F-82D3D748E29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783314-F40E-7941-9A37-C2F886E0FD62}" type="datetimeFigureOut">
              <a:rPr lang="en-GB" smtClean="0"/>
              <a:t>30/04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0E47E4-DE17-F288-A8CF-0D63DD06C8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81885A-940F-245D-F2BB-C20346B5C9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93C04-3AA1-794D-B21A-B7249CC2A9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1120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3" Type="http://schemas.openxmlformats.org/officeDocument/2006/relationships/image" Target="../media/image2.sv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5.jp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AA3D2118-E46C-9E2D-4918-42D36192A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97375" y="364103"/>
            <a:ext cx="11353800" cy="1325563"/>
          </a:xfrm>
        </p:spPr>
        <p:txBody>
          <a:bodyPr>
            <a:normAutofit fontScale="90000"/>
          </a:bodyPr>
          <a:lstStyle/>
          <a:p>
            <a:pPr algn="ctr"/>
            <a:r>
              <a:rPr lang="en-GB" sz="3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relation Between Worsening Pneumonitis and Right Ventricular Systolic Function in Critically Ill Patients with COVID-19</a:t>
            </a:r>
            <a:br>
              <a:rPr lang="en-GB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GB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PSE correlation with PaO</a:t>
            </a:r>
            <a:r>
              <a:rPr lang="en-GB" sz="24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FiO</a:t>
            </a:r>
            <a:r>
              <a:rPr lang="en-GB" sz="2400" b="1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lang="en-GB" sz="2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atio in 108 patients admitted to critical care</a:t>
            </a:r>
            <a:endParaRPr lang="en-GB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97D359C-AF5F-BAAF-20AE-2D56AB353EF3}"/>
              </a:ext>
            </a:extLst>
          </p:cNvPr>
          <p:cNvSpPr txBox="1"/>
          <p:nvPr/>
        </p:nvSpPr>
        <p:spPr>
          <a:xfrm>
            <a:off x="1305908" y="5104409"/>
            <a:ext cx="8297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TAPSE</a:t>
            </a:r>
            <a:endParaRPr lang="en-GB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22DDC8B-C1EE-ABDD-AC55-45869D1C2AD5}"/>
              </a:ext>
            </a:extLst>
          </p:cNvPr>
          <p:cNvSpPr txBox="1"/>
          <p:nvPr/>
        </p:nvSpPr>
        <p:spPr>
          <a:xfrm>
            <a:off x="2305472" y="2906916"/>
            <a:ext cx="12520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aO</a:t>
            </a:r>
            <a:r>
              <a:rPr lang="en-GB" sz="2000" b="1" baseline="-25000" dirty="0"/>
              <a:t>2</a:t>
            </a:r>
            <a:r>
              <a:rPr lang="en-GB" sz="2000" b="1" dirty="0"/>
              <a:t>/FiO</a:t>
            </a:r>
            <a:r>
              <a:rPr lang="en-GB" sz="2000" b="1" baseline="-25000" dirty="0"/>
              <a:t>2</a:t>
            </a:r>
          </a:p>
        </p:txBody>
      </p:sp>
      <p:sp>
        <p:nvSpPr>
          <p:cNvPr id="10" name="Right Arrow 9">
            <a:extLst>
              <a:ext uri="{FF2B5EF4-FFF2-40B4-BE49-F238E27FC236}">
                <a16:creationId xmlns:a16="http://schemas.microsoft.com/office/drawing/2014/main" id="{493AF3BC-BF54-0727-A99F-6EC2AD68F048}"/>
              </a:ext>
            </a:extLst>
          </p:cNvPr>
          <p:cNvSpPr/>
          <p:nvPr/>
        </p:nvSpPr>
        <p:spPr>
          <a:xfrm rot="16200000">
            <a:off x="716591" y="3804679"/>
            <a:ext cx="1996227" cy="370731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" name="Right Arrow 10">
            <a:extLst>
              <a:ext uri="{FF2B5EF4-FFF2-40B4-BE49-F238E27FC236}">
                <a16:creationId xmlns:a16="http://schemas.microsoft.com/office/drawing/2014/main" id="{6DDD9EA9-8878-9B19-95F9-D246A974590F}"/>
              </a:ext>
            </a:extLst>
          </p:cNvPr>
          <p:cNvSpPr/>
          <p:nvPr/>
        </p:nvSpPr>
        <p:spPr>
          <a:xfrm rot="5400000">
            <a:off x="1933396" y="4266345"/>
            <a:ext cx="1996227" cy="370730"/>
          </a:xfrm>
          <a:prstGeom prst="rightArrow">
            <a:avLst/>
          </a:prstGeom>
        </p:spPr>
        <p:style>
          <a:lnRef idx="3">
            <a:schemeClr val="lt1"/>
          </a:lnRef>
          <a:fillRef idx="1">
            <a:schemeClr val="dk1"/>
          </a:fillRef>
          <a:effectRef idx="1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59DA757-23E6-2CDE-7257-88138BFB5C4A}"/>
              </a:ext>
            </a:extLst>
          </p:cNvPr>
          <p:cNvSpPr txBox="1"/>
          <p:nvPr/>
        </p:nvSpPr>
        <p:spPr>
          <a:xfrm>
            <a:off x="1107953" y="5759156"/>
            <a:ext cx="21579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2000" b="1" dirty="0"/>
              <a:t>r</a:t>
            </a:r>
            <a:r>
              <a:rPr lang="en-GB" sz="2000" b="1" baseline="30000" dirty="0"/>
              <a:t>2</a:t>
            </a:r>
            <a:r>
              <a:rPr lang="en-GB" sz="2000" b="1" dirty="0"/>
              <a:t> = 0.041, p = 0.04</a:t>
            </a:r>
          </a:p>
        </p:txBody>
      </p:sp>
      <p:pic>
        <p:nvPicPr>
          <p:cNvPr id="14" name="Graphic 13" descr="Man with solid fill">
            <a:extLst>
              <a:ext uri="{FF2B5EF4-FFF2-40B4-BE49-F238E27FC236}">
                <a16:creationId xmlns:a16="http://schemas.microsoft.com/office/drawing/2014/main" id="{B28F02F0-A619-9448-BB6E-14BC855268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801913" y="2730431"/>
            <a:ext cx="1222251" cy="1222251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EA34084-8355-8326-8D38-FFE39C6D044C}"/>
              </a:ext>
            </a:extLst>
          </p:cNvPr>
          <p:cNvSpPr txBox="1"/>
          <p:nvPr/>
        </p:nvSpPr>
        <p:spPr>
          <a:xfrm>
            <a:off x="4774335" y="2896179"/>
            <a:ext cx="18076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TAPSE </a:t>
            </a:r>
            <a:r>
              <a:rPr lang="en-US" sz="2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≥</a:t>
            </a:r>
            <a:r>
              <a:rPr lang="en-GB" sz="2000" b="1" dirty="0">
                <a:effectLst/>
              </a:rPr>
              <a:t> 17 m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B8E09B9-BC12-EA52-010E-AFAF15305C8A}"/>
              </a:ext>
            </a:extLst>
          </p:cNvPr>
          <p:cNvSpPr txBox="1"/>
          <p:nvPr/>
        </p:nvSpPr>
        <p:spPr>
          <a:xfrm>
            <a:off x="4760233" y="3557521"/>
            <a:ext cx="18387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aO</a:t>
            </a:r>
            <a:r>
              <a:rPr lang="en-GB" sz="2000" b="1" baseline="-25000" dirty="0"/>
              <a:t>2</a:t>
            </a:r>
            <a:r>
              <a:rPr lang="en-GB" sz="2000" b="1" dirty="0"/>
              <a:t>/FiO</a:t>
            </a:r>
            <a:r>
              <a:rPr lang="en-GB" sz="2000" b="1" baseline="-25000" dirty="0"/>
              <a:t>2</a:t>
            </a:r>
            <a:r>
              <a:rPr lang="en-GB" sz="2000" b="1" dirty="0"/>
              <a:t>: </a:t>
            </a:r>
            <a:r>
              <a:rPr lang="en-GB" sz="2000" b="1" dirty="0">
                <a:effectLst/>
              </a:rPr>
              <a:t>18.6</a:t>
            </a:r>
          </a:p>
        </p:txBody>
      </p:sp>
      <p:pic>
        <p:nvPicPr>
          <p:cNvPr id="18" name="Graphic 17" descr="Man with solid fill">
            <a:extLst>
              <a:ext uri="{FF2B5EF4-FFF2-40B4-BE49-F238E27FC236}">
                <a16:creationId xmlns:a16="http://schemas.microsoft.com/office/drawing/2014/main" id="{88C29145-5EB9-E3A2-53CB-18F91A5063C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6432379" y="4218863"/>
            <a:ext cx="1222251" cy="1222251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2650144-74F1-6A96-355B-5C81DC6D0B66}"/>
              </a:ext>
            </a:extLst>
          </p:cNvPr>
          <p:cNvSpPr txBox="1"/>
          <p:nvPr/>
        </p:nvSpPr>
        <p:spPr>
          <a:xfrm>
            <a:off x="4760233" y="4368349"/>
            <a:ext cx="18076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TAPSE </a:t>
            </a:r>
            <a:r>
              <a:rPr lang="en-US" sz="2000" b="1" dirty="0">
                <a:latin typeface="Calibri" panose="020F0502020204030204" pitchFamily="34" charset="0"/>
                <a:cs typeface="Arial" panose="020B0604020202020204" pitchFamily="34" charset="0"/>
              </a:rPr>
              <a:t>&lt;</a:t>
            </a:r>
            <a:r>
              <a:rPr lang="en-GB" sz="2000" b="1" dirty="0">
                <a:effectLst/>
              </a:rPr>
              <a:t> 17 m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7712A65-398C-B646-A27A-35AF9EF8F2E2}"/>
              </a:ext>
            </a:extLst>
          </p:cNvPr>
          <p:cNvSpPr txBox="1"/>
          <p:nvPr/>
        </p:nvSpPr>
        <p:spPr>
          <a:xfrm>
            <a:off x="4756979" y="5058452"/>
            <a:ext cx="18387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aO</a:t>
            </a:r>
            <a:r>
              <a:rPr lang="en-GB" sz="2000" b="1" baseline="-25000" dirty="0"/>
              <a:t>2</a:t>
            </a:r>
            <a:r>
              <a:rPr lang="en-GB" sz="2000" b="1" dirty="0"/>
              <a:t>/FiO</a:t>
            </a:r>
            <a:r>
              <a:rPr lang="en-GB" sz="2000" b="1" baseline="-25000" dirty="0"/>
              <a:t>2</a:t>
            </a:r>
            <a:r>
              <a:rPr lang="en-GB" sz="2000" b="1" dirty="0"/>
              <a:t>: 32.1</a:t>
            </a:r>
            <a:endParaRPr lang="en-GB" sz="2000" b="1" dirty="0">
              <a:effectLst/>
            </a:endParaRP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06F41A37-9B09-F50D-8044-9CF2A489F81A}"/>
              </a:ext>
            </a:extLst>
          </p:cNvPr>
          <p:cNvCxnSpPr>
            <a:stCxn id="16" idx="2"/>
            <a:endCxn id="17" idx="0"/>
          </p:cNvCxnSpPr>
          <p:nvPr/>
        </p:nvCxnSpPr>
        <p:spPr>
          <a:xfrm>
            <a:off x="5678141" y="3296289"/>
            <a:ext cx="1479" cy="26123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A2992EA-F75F-82C6-7BF6-18F4AB2F0F47}"/>
              </a:ext>
            </a:extLst>
          </p:cNvPr>
          <p:cNvCxnSpPr>
            <a:cxnSpLocks/>
            <a:stCxn id="19" idx="2"/>
          </p:cNvCxnSpPr>
          <p:nvPr/>
        </p:nvCxnSpPr>
        <p:spPr>
          <a:xfrm flipH="1">
            <a:off x="5659325" y="4768459"/>
            <a:ext cx="4714" cy="28080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0C300A8B-CD37-B2AC-5226-561CD46D4B3C}"/>
              </a:ext>
            </a:extLst>
          </p:cNvPr>
          <p:cNvSpPr txBox="1"/>
          <p:nvPr/>
        </p:nvSpPr>
        <p:spPr>
          <a:xfrm>
            <a:off x="7992926" y="2033250"/>
            <a:ext cx="347662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2000" b="1" dirty="0"/>
              <a:t>PaO</a:t>
            </a:r>
            <a:r>
              <a:rPr lang="en-GB" sz="2000" b="1" baseline="-25000" dirty="0"/>
              <a:t>2</a:t>
            </a:r>
            <a:r>
              <a:rPr lang="en-GB" sz="2000" b="1" dirty="0"/>
              <a:t>/FiO</a:t>
            </a:r>
            <a:r>
              <a:rPr lang="en-GB" sz="2000" b="1" baseline="-25000" dirty="0"/>
              <a:t>2</a:t>
            </a:r>
            <a:r>
              <a:rPr lang="en-GB" sz="2000" b="1" dirty="0"/>
              <a:t> prediction of TAPSE </a:t>
            </a:r>
            <a:r>
              <a:rPr lang="en-US" sz="2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≥ or &lt;</a:t>
            </a:r>
            <a:r>
              <a:rPr lang="en-GB" sz="2000" b="1" dirty="0"/>
              <a:t> 17 mm</a:t>
            </a:r>
            <a:endParaRPr lang="en-GB" sz="2000" b="1" dirty="0">
              <a:effectLst/>
            </a:endParaRPr>
          </a:p>
        </p:txBody>
      </p:sp>
      <p:pic>
        <p:nvPicPr>
          <p:cNvPr id="31" name="Picture 30" descr="A graph of sensitivity&#10;&#10;Description automatically generated">
            <a:extLst>
              <a:ext uri="{FF2B5EF4-FFF2-40B4-BE49-F238E27FC236}">
                <a16:creationId xmlns:a16="http://schemas.microsoft.com/office/drawing/2014/main" id="{98E9ECF4-EF31-7F04-860B-B59D3109483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20403" y="2844231"/>
            <a:ext cx="3610866" cy="3284091"/>
          </a:xfrm>
          <a:prstGeom prst="rect">
            <a:avLst/>
          </a:prstGeom>
        </p:spPr>
      </p:pic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48DFD1EB-F842-84AA-6528-1B831693B9FB}"/>
              </a:ext>
            </a:extLst>
          </p:cNvPr>
          <p:cNvCxnSpPr>
            <a:cxnSpLocks/>
          </p:cNvCxnSpPr>
          <p:nvPr/>
        </p:nvCxnSpPr>
        <p:spPr>
          <a:xfrm>
            <a:off x="3872937" y="1942657"/>
            <a:ext cx="0" cy="4221573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29E929A-FE9B-76DE-FD8A-423C781E2134}"/>
              </a:ext>
            </a:extLst>
          </p:cNvPr>
          <p:cNvCxnSpPr>
            <a:cxnSpLocks/>
          </p:cNvCxnSpPr>
          <p:nvPr/>
        </p:nvCxnSpPr>
        <p:spPr>
          <a:xfrm>
            <a:off x="7725800" y="1942657"/>
            <a:ext cx="0" cy="4221573"/>
          </a:xfrm>
          <a:prstGeom prst="line">
            <a:avLst/>
          </a:prstGeom>
          <a:ln w="1905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FD87C622-714A-03C2-26DC-89CB5C5CC80B}"/>
              </a:ext>
            </a:extLst>
          </p:cNvPr>
          <p:cNvSpPr txBox="1"/>
          <p:nvPr/>
        </p:nvSpPr>
        <p:spPr>
          <a:xfrm>
            <a:off x="5081449" y="5728933"/>
            <a:ext cx="11544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p = 0.005</a:t>
            </a:r>
            <a:endParaRPr lang="en-GB" sz="1600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6BD18DF-62E7-A891-D7B6-3D6A39303E29}"/>
              </a:ext>
            </a:extLst>
          </p:cNvPr>
          <p:cNvSpPr txBox="1"/>
          <p:nvPr/>
        </p:nvSpPr>
        <p:spPr>
          <a:xfrm>
            <a:off x="5420066" y="3968239"/>
            <a:ext cx="4772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/>
              <a:t>vs.</a:t>
            </a:r>
            <a:endParaRPr lang="en-GB" sz="1600" b="1" dirty="0"/>
          </a:p>
        </p:txBody>
      </p:sp>
      <p:pic>
        <p:nvPicPr>
          <p:cNvPr id="5" name="Graphic 4" descr="Link with solid fill">
            <a:extLst>
              <a:ext uri="{FF2B5EF4-FFF2-40B4-BE49-F238E27FC236}">
                <a16:creationId xmlns:a16="http://schemas.microsoft.com/office/drawing/2014/main" id="{05C3CEE6-F8E6-E04C-22D5-339C60E93EA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>
            <a:off x="1921110" y="3723822"/>
            <a:ext cx="825034" cy="82503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567B116-9607-F891-7CD3-CB8040E391DA}"/>
              </a:ext>
            </a:extLst>
          </p:cNvPr>
          <p:cNvSpPr txBox="1"/>
          <p:nvPr/>
        </p:nvSpPr>
        <p:spPr>
          <a:xfrm>
            <a:off x="397375" y="1997420"/>
            <a:ext cx="347662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2000" b="1" dirty="0"/>
              <a:t>TAPSE association with PaO</a:t>
            </a:r>
            <a:r>
              <a:rPr lang="en-GB" sz="2000" b="1" baseline="-25000" dirty="0"/>
              <a:t>2</a:t>
            </a:r>
            <a:r>
              <a:rPr lang="en-GB" sz="2000" b="1" dirty="0"/>
              <a:t>/FiO</a:t>
            </a:r>
            <a:r>
              <a:rPr lang="en-GB" sz="2000" b="1" baseline="-25000" dirty="0"/>
              <a:t>2</a:t>
            </a:r>
            <a:r>
              <a:rPr lang="en-GB" sz="2000" b="1" dirty="0"/>
              <a:t> ratio</a:t>
            </a:r>
            <a:endParaRPr lang="en-GB" sz="2000" b="1" dirty="0">
              <a:effectLst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003E853-55C3-B324-FFD0-9ED4A00B51FB}"/>
              </a:ext>
            </a:extLst>
          </p:cNvPr>
          <p:cNvSpPr txBox="1"/>
          <p:nvPr/>
        </p:nvSpPr>
        <p:spPr>
          <a:xfrm>
            <a:off x="3982051" y="2028120"/>
            <a:ext cx="347662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2000" b="1" dirty="0"/>
              <a:t>PaO</a:t>
            </a:r>
            <a:r>
              <a:rPr lang="en-GB" sz="2000" b="1" baseline="-25000" dirty="0"/>
              <a:t>2</a:t>
            </a:r>
            <a:r>
              <a:rPr lang="en-GB" sz="2000" b="1" dirty="0"/>
              <a:t>/FiO</a:t>
            </a:r>
            <a:r>
              <a:rPr lang="en-GB" sz="2000" b="1" baseline="-25000" dirty="0"/>
              <a:t>2 </a:t>
            </a:r>
            <a:r>
              <a:rPr lang="en-GB" sz="2000" b="1" dirty="0"/>
              <a:t>ratio based on TAPSE </a:t>
            </a:r>
            <a:r>
              <a:rPr lang="en-US" sz="2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≥ or &lt;</a:t>
            </a:r>
            <a:r>
              <a:rPr lang="en-GB" sz="2000" b="1" dirty="0"/>
              <a:t> 17 mm</a:t>
            </a:r>
            <a:endParaRPr lang="en-GB" sz="2000" b="1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192143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95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Correlation Between Worsening Pneumonitis and Right Ventricular Systolic Function in Critically Ill Patients with COVID-19  TAPSE correlation with PaO2/FiO2 ratio in 108 patients admitted to critical car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ight Ventricular Systolic Function Increased as Pneumonitis Worsened in COVID-19: A Retrospective Cohort Study.  TAPSE correlation with PaO2/FiO2 ratio in 108 patients admitted to critical care</dc:title>
  <dc:creator>LASHIN, Hazem (BARTS HEALTH NHS TRUST)</dc:creator>
  <cp:lastModifiedBy>LASHIN, Hazem (BARTS HEALTH NHS TRUST)</cp:lastModifiedBy>
  <cp:revision>11</cp:revision>
  <dcterms:created xsi:type="dcterms:W3CDTF">2023-09-21T11:19:12Z</dcterms:created>
  <dcterms:modified xsi:type="dcterms:W3CDTF">2024-04-30T12:35:28Z</dcterms:modified>
</cp:coreProperties>
</file>